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20" d="100"/>
          <a:sy n="220" d="100"/>
        </p:scale>
        <p:origin x="4806" y="34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798C-FCFC-420D-A37E-C7BB86A31F1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A9DE-0D2E-4F74-8938-4227D9975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650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798C-FCFC-420D-A37E-C7BB86A31F1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A9DE-0D2E-4F74-8938-4227D9975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7716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798C-FCFC-420D-A37E-C7BB86A31F1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A9DE-0D2E-4F74-8938-4227D9975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839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798C-FCFC-420D-A37E-C7BB86A31F1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A9DE-0D2E-4F74-8938-4227D9975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903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798C-FCFC-420D-A37E-C7BB86A31F1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A9DE-0D2E-4F74-8938-4227D9975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638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798C-FCFC-420D-A37E-C7BB86A31F1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A9DE-0D2E-4F74-8938-4227D9975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8954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798C-FCFC-420D-A37E-C7BB86A31F1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A9DE-0D2E-4F74-8938-4227D9975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711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798C-FCFC-420D-A37E-C7BB86A31F1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A9DE-0D2E-4F74-8938-4227D9975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1028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798C-FCFC-420D-A37E-C7BB86A31F1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A9DE-0D2E-4F74-8938-4227D9975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126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798C-FCFC-420D-A37E-C7BB86A31F1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A9DE-0D2E-4F74-8938-4227D9975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3529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798C-FCFC-420D-A37E-C7BB86A31F1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AA9DE-0D2E-4F74-8938-4227D9975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733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5798C-FCFC-420D-A37E-C7BB86A31F1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9AA9DE-0D2E-4F74-8938-4227D99755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1807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2" t="1375" r="1277" b="1751"/>
          <a:stretch/>
        </p:blipFill>
        <p:spPr bwMode="auto">
          <a:xfrm>
            <a:off x="792270" y="361039"/>
            <a:ext cx="3546230" cy="32004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6924" y="392880"/>
            <a:ext cx="3650255" cy="316855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04"/>
          <a:stretch/>
        </p:blipFill>
        <p:spPr bwMode="auto">
          <a:xfrm>
            <a:off x="772340" y="3657600"/>
            <a:ext cx="3566160" cy="307147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822078" y="347246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632078" y="347246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822078" y="365762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" name="Rectangle 4"/>
          <p:cNvSpPr/>
          <p:nvPr/>
        </p:nvSpPr>
        <p:spPr>
          <a:xfrm>
            <a:off x="4760852" y="4308240"/>
            <a:ext cx="3697347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smtClean="0">
                <a:latin typeface="Arial" panose="020B0604020202020204" pitchFamily="34" charset="0"/>
                <a:cs typeface="Arial" panose="020B0604020202020204" pitchFamily="34" charset="0"/>
              </a:rPr>
              <a:t>SF1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itami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 mediated changes in the expression of genes in the inflammation regulatory network in 143B human OS cells during proliferation (A), post-proliferation (B), and differentiation (C). The yellow color denotes transcription factors while the green and red color indicate vitamin D induced down and up regulated genes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3330444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62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Veteran Affair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imella, Rama (KCVA)</dc:creator>
  <cp:lastModifiedBy>Garimella, Rama (KCVA)</cp:lastModifiedBy>
  <cp:revision>5</cp:revision>
  <dcterms:created xsi:type="dcterms:W3CDTF">2016-03-21T18:30:54Z</dcterms:created>
  <dcterms:modified xsi:type="dcterms:W3CDTF">2017-03-14T17:46:10Z</dcterms:modified>
</cp:coreProperties>
</file>